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74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32" y="1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1764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435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2860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3452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097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75951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3877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524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703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3960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6684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4AA119-6DDE-4DDC-B84A-4E9959E22F20}" type="datetimeFigureOut">
              <a:rPr lang="en-US" smtClean="0"/>
              <a:t>5/7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DA62F7-E483-4812-B186-123EE2A723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2425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68286" y="638460"/>
            <a:ext cx="6849628" cy="3268521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491465" y="4954321"/>
            <a:ext cx="9733190" cy="10259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1 Fig.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 </a:t>
            </a:r>
            <a:r>
              <a:rPr lang="en-US" sz="12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PLC </a:t>
            </a:r>
            <a:r>
              <a:rPr lang="en-US" sz="12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hromatogram of </a:t>
            </a:r>
            <a:r>
              <a:rPr lang="en-US" sz="1200" b="1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ederacoside</a:t>
            </a:r>
            <a:r>
              <a:rPr lang="en-US" sz="1200" b="1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D and </a:t>
            </a:r>
            <a:r>
              <a:rPr lang="en-US" sz="1200" b="1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orroniside</a:t>
            </a:r>
            <a:r>
              <a:rPr lang="en-US" sz="1200" b="1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in SC extract. </a:t>
            </a:r>
            <a:endParaRPr lang="en-US" sz="1200" b="1" dirty="0" smtClean="0">
              <a:latin typeface="Times New Roman" panose="02020603050405020304" pitchFamily="18" charset="0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800"/>
              </a:spcAft>
            </a:pPr>
            <a:r>
              <a:rPr lang="en-GB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Molecular structure of </a:t>
            </a:r>
            <a:r>
              <a:rPr lang="en-US" sz="1200" dirty="0" err="1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ederacoside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. (B)</a:t>
            </a:r>
            <a:r>
              <a:rPr lang="en-GB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nstituent of </a:t>
            </a:r>
            <a:r>
              <a:rPr lang="en-US" sz="12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ederacoside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 in the SC extract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alyzed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y HPLC-PDA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r>
              <a:rPr lang="en-GB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C) Molecular structure of </a:t>
            </a:r>
            <a:r>
              <a:rPr lang="en-GB" sz="1200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orroniside</a:t>
            </a:r>
            <a:r>
              <a:rPr lang="en-GB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(D)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nstituent of </a:t>
            </a:r>
            <a:r>
              <a:rPr lang="en-US" sz="1200" dirty="0" err="1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morroniside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in the SC extract 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alyzed </a:t>
            </a:r>
            <a:r>
              <a:rPr lang="en-US" sz="1200" dirty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by HPLC-PDA</a:t>
            </a:r>
            <a:r>
              <a:rPr lang="en-US" sz="1200" dirty="0" smtClean="0"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6846896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</cp:revision>
  <dcterms:created xsi:type="dcterms:W3CDTF">2020-05-07T04:44:34Z</dcterms:created>
  <dcterms:modified xsi:type="dcterms:W3CDTF">2020-05-07T04:45:00Z</dcterms:modified>
</cp:coreProperties>
</file>